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28" d="100"/>
          <a:sy n="28" d="100"/>
        </p:scale>
        <p:origin x="2274" y="114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3098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0198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2894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3074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9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486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2731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0678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9806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0614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1123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9299F-40A3-4ED3-A86B-644C2D952BAF}" type="datetimeFigureOut">
              <a:rPr lang="fr-FR" smtClean="0"/>
              <a:t>23/08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A2887-4D43-46F2-B89A-61ADA951F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347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5" descr="D:\Documents and Settings\410864\Mes documents\RTinserm\proj mecanismes\cytoskellette\verif taxol et Jaspa\070814\TAXOL\TUB\20\Tv68 [1]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408" y="12370004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4" descr="D:\Documents and Settings\410864\Mes documents\RTinserm\proj mecanismes\cytoskellette\verif taxol et Jaspa\070814\TAXOL\TUB\5\Tv72 [1]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383" y="12399820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3" descr="D:\Documents and Settings\410864\Mes documents\RTinserm\proj mecanismes\cytoskellette\verif taxol et Jaspa\070814\TAXOL\TUB\2.5\Tv74 [1]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6077" y="8575917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2" descr="D:\Documents and Settings\410864\Mes documents\RTinserm\proj mecanismes\cytoskellette\verif taxol et Jaspa\070814\TAXOL\TUB\0\Tv66 [1]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383" y="8554004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6" name="Picture 2" descr="D:\Documents and Settings\410864\Mes documents\RTinserm\proj mecanismes\cytoskellette\verif taxol et Jaspa\070814\jasp 210314\ACTIN\12.5\Tv52 [1].ti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985" y="471493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3" descr="D:\Documents and Settings\410864\Mes documents\RTinserm\proj mecanismes\cytoskellette\verif taxol et Jaspa\070814\jasp 210314\ACTIN\50\Tv56 [1].tif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414" y="471493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4" descr="D:\Documents and Settings\410864\Mes documents\RTinserm\proj mecanismes\cytoskellette\verif taxol et Jaspa\070814\jasp 210314\ACTIN\100\Tv58 [1] [1].tif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3569" y="4302974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5" descr="D:\Documents and Settings\410864\Mes documents\RTinserm\proj mecanismes\cytoskellette\verif taxol et Jaspa\070814\jasp 210314\ACTIN\200\Tv60 [1].tif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0986" y="4302635"/>
            <a:ext cx="5095008" cy="38160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ZoneTexte 18"/>
          <p:cNvSpPr txBox="1"/>
          <p:nvPr/>
        </p:nvSpPr>
        <p:spPr>
          <a:xfrm>
            <a:off x="0" y="8133882"/>
            <a:ext cx="12192000" cy="442035"/>
          </a:xfrm>
          <a:prstGeom prst="rect">
            <a:avLst/>
          </a:prstGeom>
          <a:solidFill>
            <a:schemeClr val="bg1"/>
          </a:solidFill>
        </p:spPr>
        <p:txBody>
          <a:bodyPr wrap="square" tIns="36000" bIns="36000" rtlCol="0">
            <a:spAutoFit/>
          </a:bodyPr>
          <a:lstStyle/>
          <a:p>
            <a:pPr algn="ctr"/>
            <a:r>
              <a:rPr lang="fr-FR" sz="2400" b="1" dirty="0"/>
              <a:t>24h incubation at 4°C </a:t>
            </a:r>
            <a:r>
              <a:rPr lang="fr-FR" sz="2400" b="1" dirty="0" err="1"/>
              <a:t>with</a:t>
            </a:r>
            <a:r>
              <a:rPr lang="fr-FR" sz="2400" b="1" dirty="0"/>
              <a:t> </a:t>
            </a:r>
            <a:r>
              <a:rPr lang="fr-FR" sz="2400" b="1" dirty="0" smtClean="0"/>
              <a:t>Taxol</a:t>
            </a:r>
            <a:endParaRPr lang="fr-FR" sz="24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892468" y="8732410"/>
            <a:ext cx="782587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0µ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9960568" y="8711207"/>
            <a:ext cx="1019831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2.5µ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884453" y="12496300"/>
            <a:ext cx="782587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5µ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10088808" y="12477250"/>
            <a:ext cx="938077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20µ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0" y="0"/>
            <a:ext cx="12192000" cy="442035"/>
          </a:xfrm>
          <a:prstGeom prst="rect">
            <a:avLst/>
          </a:prstGeom>
          <a:solidFill>
            <a:schemeClr val="bg1"/>
          </a:solidFill>
        </p:spPr>
        <p:txBody>
          <a:bodyPr wrap="square" tIns="36000" bIns="36000" rtlCol="0">
            <a:spAutoFit/>
          </a:bodyPr>
          <a:lstStyle/>
          <a:p>
            <a:pPr algn="ctr"/>
            <a:r>
              <a:rPr lang="fr-FR" sz="2400" b="1" dirty="0" smtClean="0"/>
              <a:t>24h incubation at 4°C </a:t>
            </a:r>
            <a:r>
              <a:rPr lang="fr-FR" sz="2400" b="1" dirty="0" err="1" smtClean="0"/>
              <a:t>with</a:t>
            </a:r>
            <a:r>
              <a:rPr lang="fr-FR" sz="2400" b="1" dirty="0" smtClean="0"/>
              <a:t> </a:t>
            </a:r>
            <a:r>
              <a:rPr lang="fr-FR" sz="2400" b="1" dirty="0" err="1" smtClean="0"/>
              <a:t>Jaspakinolide</a:t>
            </a:r>
            <a:endParaRPr lang="fr-FR" sz="2400" b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892468" y="553335"/>
            <a:ext cx="1167307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12.5n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9814668" y="553335"/>
            <a:ext cx="930063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50n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892468" y="4370475"/>
            <a:ext cx="1085554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100n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10088808" y="4370475"/>
            <a:ext cx="1085554" cy="461665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altLang="fr-FR" sz="2400" b="1" dirty="0">
                <a:solidFill>
                  <a:srgbClr val="FFFFFF"/>
                </a:solidFill>
              </a:rPr>
              <a:t>200nM</a:t>
            </a:r>
            <a:endParaRPr lang="fr-FR" sz="2400" b="1" dirty="0">
              <a:solidFill>
                <a:schemeClr val="bg1"/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 rot="16200000">
            <a:off x="10323671" y="13146066"/>
            <a:ext cx="27257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600" dirty="0" smtClean="0">
                <a:solidFill>
                  <a:schemeClr val="bg1"/>
                </a:solidFill>
              </a:rPr>
              <a:t>Figure </a:t>
            </a:r>
            <a:r>
              <a:rPr lang="fr-FR" sz="3600" dirty="0" err="1" smtClean="0">
                <a:solidFill>
                  <a:schemeClr val="bg1"/>
                </a:solidFill>
              </a:rPr>
              <a:t>Supp</a:t>
            </a:r>
            <a:r>
              <a:rPr lang="fr-FR" sz="3600" dirty="0" smtClean="0">
                <a:solidFill>
                  <a:schemeClr val="bg1"/>
                </a:solidFill>
              </a:rPr>
              <a:t> 6</a:t>
            </a:r>
            <a:endParaRPr lang="fr-FR" sz="36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51403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23</Words>
  <Application>Microsoft Office PowerPoint</Application>
  <PresentationFormat>Personnalisé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T</dc:creator>
  <cp:lastModifiedBy>RT</cp:lastModifiedBy>
  <cp:revision>30</cp:revision>
  <cp:lastPrinted>2017-08-23T14:11:41Z</cp:lastPrinted>
  <dcterms:created xsi:type="dcterms:W3CDTF">2015-10-22T11:59:22Z</dcterms:created>
  <dcterms:modified xsi:type="dcterms:W3CDTF">2017-08-23T14:11:49Z</dcterms:modified>
</cp:coreProperties>
</file>